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1" r:id="rId2"/>
  </p:sldIdLst>
  <p:sldSz cx="6858000" cy="9144000" type="screen4x3"/>
  <p:notesSz cx="6858000" cy="994568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4CDB691A-5B7D-46BD-B5CA-01008D914837}" v="2" dt="2020-09-08T12:32:43.755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898" autoAdjust="0"/>
    <p:restoredTop sz="94660"/>
  </p:normalViewPr>
  <p:slideViewPr>
    <p:cSldViewPr snapToGrid="0">
      <p:cViewPr varScale="1">
        <p:scale>
          <a:sx n="86" d="100"/>
          <a:sy n="86" d="100"/>
        </p:scale>
        <p:origin x="3048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金子 慶三" userId="5f97e7106065bcb4" providerId="LiveId" clId="{8839C90D-A0BC-41D0-9324-9C661B7E5A1D}"/>
    <pc:docChg chg="custSel addSld delSld modSld sldOrd">
      <pc:chgData name="金子 慶三" userId="5f97e7106065bcb4" providerId="LiveId" clId="{8839C90D-A0BC-41D0-9324-9C661B7E5A1D}" dt="2020-08-25T06:20:02.757" v="486" actId="478"/>
      <pc:docMkLst>
        <pc:docMk/>
      </pc:docMkLst>
      <pc:sldChg chg="addSp delSp modSp add del mod">
        <pc:chgData name="金子 慶三" userId="5f97e7106065bcb4" providerId="LiveId" clId="{8839C90D-A0BC-41D0-9324-9C661B7E5A1D}" dt="2020-08-25T06:12:25.246" v="443" actId="21"/>
        <pc:sldMkLst>
          <pc:docMk/>
          <pc:sldMk cId="3017841347" sldId="256"/>
        </pc:sldMkLst>
        <pc:spChg chg="mod">
          <ac:chgData name="金子 慶三" userId="5f97e7106065bcb4" providerId="LiveId" clId="{8839C90D-A0BC-41D0-9324-9C661B7E5A1D}" dt="2020-08-25T04:45:08.190" v="414" actId="1076"/>
          <ac:spMkLst>
            <pc:docMk/>
            <pc:sldMk cId="3017841347" sldId="256"/>
            <ac:spMk id="4" creationId="{00000000-0000-0000-0000-000000000000}"/>
          </ac:spMkLst>
        </pc:spChg>
        <pc:spChg chg="add mod">
          <ac:chgData name="金子 慶三" userId="5f97e7106065bcb4" providerId="LiveId" clId="{8839C90D-A0BC-41D0-9324-9C661B7E5A1D}" dt="2020-08-22T02:40:20.798" v="177"/>
          <ac:spMkLst>
            <pc:docMk/>
            <pc:sldMk cId="3017841347" sldId="256"/>
            <ac:spMk id="5" creationId="{24F344B8-3235-4BC5-BF95-5FCB126764F6}"/>
          </ac:spMkLst>
        </pc:spChg>
        <pc:spChg chg="mod">
          <ac:chgData name="金子 慶三" userId="5f97e7106065bcb4" providerId="LiveId" clId="{8839C90D-A0BC-41D0-9324-9C661B7E5A1D}" dt="2020-08-25T04:31:46.739" v="408" actId="1076"/>
          <ac:spMkLst>
            <pc:docMk/>
            <pc:sldMk cId="3017841347" sldId="256"/>
            <ac:spMk id="45" creationId="{00000000-0000-0000-0000-000000000000}"/>
          </ac:spMkLst>
        </pc:spChg>
        <pc:picChg chg="add del mod">
          <ac:chgData name="金子 慶三" userId="5f97e7106065bcb4" providerId="LiveId" clId="{8839C90D-A0BC-41D0-9324-9C661B7E5A1D}" dt="2020-08-25T06:12:25.246" v="443" actId="21"/>
          <ac:picMkLst>
            <pc:docMk/>
            <pc:sldMk cId="3017841347" sldId="256"/>
            <ac:picMk id="6" creationId="{1DB7F924-6D0B-402F-A8E1-3790D96C4ABA}"/>
          </ac:picMkLst>
        </pc:picChg>
      </pc:sldChg>
      <pc:sldChg chg="del">
        <pc:chgData name="金子 慶三" userId="5f97e7106065bcb4" providerId="LiveId" clId="{8839C90D-A0BC-41D0-9324-9C661B7E5A1D}" dt="2020-08-22T01:54:20.422" v="1" actId="47"/>
        <pc:sldMkLst>
          <pc:docMk/>
          <pc:sldMk cId="1050505833" sldId="257"/>
        </pc:sldMkLst>
      </pc:sldChg>
      <pc:sldChg chg="del">
        <pc:chgData name="金子 慶三" userId="5f97e7106065bcb4" providerId="LiveId" clId="{8839C90D-A0BC-41D0-9324-9C661B7E5A1D}" dt="2020-08-22T01:54:24.254" v="3" actId="47"/>
        <pc:sldMkLst>
          <pc:docMk/>
          <pc:sldMk cId="2806426196" sldId="258"/>
        </pc:sldMkLst>
      </pc:sldChg>
      <pc:sldChg chg="del">
        <pc:chgData name="金子 慶三" userId="5f97e7106065bcb4" providerId="LiveId" clId="{8839C90D-A0BC-41D0-9324-9C661B7E5A1D}" dt="2020-08-22T01:54:22.772" v="2" actId="47"/>
        <pc:sldMkLst>
          <pc:docMk/>
          <pc:sldMk cId="1927085752" sldId="259"/>
        </pc:sldMkLst>
      </pc:sldChg>
      <pc:sldChg chg="addSp delSp modSp del mod">
        <pc:chgData name="金子 慶三" userId="5f97e7106065bcb4" providerId="LiveId" clId="{8839C90D-A0BC-41D0-9324-9C661B7E5A1D}" dt="2020-08-25T04:32:55.134" v="412" actId="47"/>
        <pc:sldMkLst>
          <pc:docMk/>
          <pc:sldMk cId="2868810145" sldId="260"/>
        </pc:sldMkLst>
        <pc:spChg chg="mod">
          <ac:chgData name="金子 慶三" userId="5f97e7106065bcb4" providerId="LiveId" clId="{8839C90D-A0BC-41D0-9324-9C661B7E5A1D}" dt="2020-08-22T01:55:54.353" v="5" actId="14100"/>
          <ac:spMkLst>
            <pc:docMk/>
            <pc:sldMk cId="2868810145" sldId="260"/>
            <ac:spMk id="2" creationId="{5CFFB926-31B6-410E-8AA3-E21E67C0E618}"/>
          </ac:spMkLst>
        </pc:spChg>
        <pc:spChg chg="mod">
          <ac:chgData name="金子 慶三" userId="5f97e7106065bcb4" providerId="LiveId" clId="{8839C90D-A0BC-41D0-9324-9C661B7E5A1D}" dt="2020-08-23T02:30:46.229" v="240"/>
          <ac:spMkLst>
            <pc:docMk/>
            <pc:sldMk cId="2868810145" sldId="260"/>
            <ac:spMk id="3" creationId="{00000000-0000-0000-0000-000000000000}"/>
          </ac:spMkLst>
        </pc:spChg>
        <pc:spChg chg="mod">
          <ac:chgData name="金子 慶三" userId="5f97e7106065bcb4" providerId="LiveId" clId="{8839C90D-A0BC-41D0-9324-9C661B7E5A1D}" dt="2020-08-23T05:11:56.512" v="244" actId="2710"/>
          <ac:spMkLst>
            <pc:docMk/>
            <pc:sldMk cId="2868810145" sldId="260"/>
            <ac:spMk id="4" creationId="{00000000-0000-0000-0000-000000000000}"/>
          </ac:spMkLst>
        </pc:spChg>
        <pc:spChg chg="mod">
          <ac:chgData name="金子 慶三" userId="5f97e7106065bcb4" providerId="LiveId" clId="{8839C90D-A0BC-41D0-9324-9C661B7E5A1D}" dt="2020-08-22T02:16:19.928" v="24" actId="1035"/>
          <ac:spMkLst>
            <pc:docMk/>
            <pc:sldMk cId="2868810145" sldId="260"/>
            <ac:spMk id="35" creationId="{1E7E3055-5ADD-4BFE-B10D-171ECFD002D3}"/>
          </ac:spMkLst>
        </pc:spChg>
        <pc:spChg chg="mod">
          <ac:chgData name="金子 慶三" userId="5f97e7106065bcb4" providerId="LiveId" clId="{8839C90D-A0BC-41D0-9324-9C661B7E5A1D}" dt="2020-08-22T02:16:19.928" v="24" actId="1035"/>
          <ac:spMkLst>
            <pc:docMk/>
            <pc:sldMk cId="2868810145" sldId="260"/>
            <ac:spMk id="36" creationId="{9B87BA29-1F76-4FCF-A2B6-3B995915DA1E}"/>
          </ac:spMkLst>
        </pc:spChg>
        <pc:spChg chg="mod">
          <ac:chgData name="金子 慶三" userId="5f97e7106065bcb4" providerId="LiveId" clId="{8839C90D-A0BC-41D0-9324-9C661B7E5A1D}" dt="2020-08-22T02:16:19.928" v="24" actId="1035"/>
          <ac:spMkLst>
            <pc:docMk/>
            <pc:sldMk cId="2868810145" sldId="260"/>
            <ac:spMk id="37" creationId="{D9AD1A19-F6FF-43C9-A1F7-03ABB223447B}"/>
          </ac:spMkLst>
        </pc:spChg>
        <pc:spChg chg="mod">
          <ac:chgData name="金子 慶三" userId="5f97e7106065bcb4" providerId="LiveId" clId="{8839C90D-A0BC-41D0-9324-9C661B7E5A1D}" dt="2020-08-22T02:16:19.928" v="24" actId="1035"/>
          <ac:spMkLst>
            <pc:docMk/>
            <pc:sldMk cId="2868810145" sldId="260"/>
            <ac:spMk id="38" creationId="{949F5B70-9EF8-4AC3-BDDC-7C947B486BDC}"/>
          </ac:spMkLst>
        </pc:spChg>
        <pc:spChg chg="mod">
          <ac:chgData name="金子 慶三" userId="5f97e7106065bcb4" providerId="LiveId" clId="{8839C90D-A0BC-41D0-9324-9C661B7E5A1D}" dt="2020-08-22T02:16:19.928" v="24" actId="1035"/>
          <ac:spMkLst>
            <pc:docMk/>
            <pc:sldMk cId="2868810145" sldId="260"/>
            <ac:spMk id="39" creationId="{6938971D-62F2-4670-850C-3DD0BB23519F}"/>
          </ac:spMkLst>
        </pc:spChg>
        <pc:spChg chg="mod">
          <ac:chgData name="金子 慶三" userId="5f97e7106065bcb4" providerId="LiveId" clId="{8839C90D-A0BC-41D0-9324-9C661B7E5A1D}" dt="2020-08-22T02:16:19.928" v="24" actId="1035"/>
          <ac:spMkLst>
            <pc:docMk/>
            <pc:sldMk cId="2868810145" sldId="260"/>
            <ac:spMk id="40" creationId="{32A4BF40-EA71-41CC-B27A-67671830ECEE}"/>
          </ac:spMkLst>
        </pc:spChg>
        <pc:spChg chg="mod">
          <ac:chgData name="金子 慶三" userId="5f97e7106065bcb4" providerId="LiveId" clId="{8839C90D-A0BC-41D0-9324-9C661B7E5A1D}" dt="2020-08-22T02:16:19.928" v="24" actId="1035"/>
          <ac:spMkLst>
            <pc:docMk/>
            <pc:sldMk cId="2868810145" sldId="260"/>
            <ac:spMk id="43" creationId="{82E9BF78-9BA5-41F8-AC14-592CBF7A5B76}"/>
          </ac:spMkLst>
        </pc:spChg>
        <pc:spChg chg="mod">
          <ac:chgData name="金子 慶三" userId="5f97e7106065bcb4" providerId="LiveId" clId="{8839C90D-A0BC-41D0-9324-9C661B7E5A1D}" dt="2020-08-23T02:26:46.661" v="216" actId="20577"/>
          <ac:spMkLst>
            <pc:docMk/>
            <pc:sldMk cId="2868810145" sldId="260"/>
            <ac:spMk id="44" creationId="{A02B0A61-4441-452C-A296-75215B7D24CB}"/>
          </ac:spMkLst>
        </pc:spChg>
        <pc:spChg chg="del mod">
          <ac:chgData name="金子 慶三" userId="5f97e7106065bcb4" providerId="LiveId" clId="{8839C90D-A0BC-41D0-9324-9C661B7E5A1D}" dt="2020-08-23T02:33:46.444" v="243"/>
          <ac:spMkLst>
            <pc:docMk/>
            <pc:sldMk cId="2868810145" sldId="260"/>
            <ac:spMk id="45" creationId="{00000000-0000-0000-0000-000000000000}"/>
          </ac:spMkLst>
        </pc:spChg>
        <pc:picChg chg="del">
          <ac:chgData name="金子 慶三" userId="5f97e7106065bcb4" providerId="LiveId" clId="{8839C90D-A0BC-41D0-9324-9C661B7E5A1D}" dt="2020-08-22T02:15:54.517" v="16" actId="478"/>
          <ac:picMkLst>
            <pc:docMk/>
            <pc:sldMk cId="2868810145" sldId="260"/>
            <ac:picMk id="6" creationId="{506CE10A-5E5F-4D02-9631-F9B8E4E80531}"/>
          </ac:picMkLst>
        </pc:picChg>
        <pc:picChg chg="add mod ord modCrop">
          <ac:chgData name="金子 慶三" userId="5f97e7106065bcb4" providerId="LiveId" clId="{8839C90D-A0BC-41D0-9324-9C661B7E5A1D}" dt="2020-08-22T03:21:49.531" v="214" actId="1076"/>
          <ac:picMkLst>
            <pc:docMk/>
            <pc:sldMk cId="2868810145" sldId="260"/>
            <ac:picMk id="6" creationId="{97A273FB-BD49-4F34-A144-08C6EFBD6D6A}"/>
          </ac:picMkLst>
        </pc:picChg>
        <pc:picChg chg="add del">
          <ac:chgData name="金子 慶三" userId="5f97e7106065bcb4" providerId="LiveId" clId="{8839C90D-A0BC-41D0-9324-9C661B7E5A1D}" dt="2020-08-22T02:07:40.047" v="7" actId="478"/>
          <ac:picMkLst>
            <pc:docMk/>
            <pc:sldMk cId="2868810145" sldId="260"/>
            <ac:picMk id="9" creationId="{969638AE-54E5-4E6E-A3A6-960FB2E66F44}"/>
          </ac:picMkLst>
        </pc:picChg>
        <pc:picChg chg="add del mod ord">
          <ac:chgData name="金子 慶三" userId="5f97e7106065bcb4" providerId="LiveId" clId="{8839C90D-A0BC-41D0-9324-9C661B7E5A1D}" dt="2020-08-22T03:21:10.619" v="189" actId="478"/>
          <ac:picMkLst>
            <pc:docMk/>
            <pc:sldMk cId="2868810145" sldId="260"/>
            <ac:picMk id="11" creationId="{771AEBB3-2061-43FA-BDB7-83F42E0B2411}"/>
          </ac:picMkLst>
        </pc:picChg>
      </pc:sldChg>
      <pc:sldChg chg="delSp new del mod">
        <pc:chgData name="金子 慶三" userId="5f97e7106065bcb4" providerId="LiveId" clId="{8839C90D-A0BC-41D0-9324-9C661B7E5A1D}" dt="2020-08-22T02:34:15.562" v="131" actId="47"/>
        <pc:sldMkLst>
          <pc:docMk/>
          <pc:sldMk cId="1246805283" sldId="261"/>
        </pc:sldMkLst>
        <pc:spChg chg="del">
          <ac:chgData name="金子 慶三" userId="5f97e7106065bcb4" providerId="LiveId" clId="{8839C90D-A0BC-41D0-9324-9C661B7E5A1D}" dt="2020-08-22T02:28:47.216" v="129" actId="478"/>
          <ac:spMkLst>
            <pc:docMk/>
            <pc:sldMk cId="1246805283" sldId="261"/>
            <ac:spMk id="2" creationId="{AD8E9252-1CC5-4A60-8D89-3BB6E4C35061}"/>
          </ac:spMkLst>
        </pc:spChg>
        <pc:spChg chg="del">
          <ac:chgData name="金子 慶三" userId="5f97e7106065bcb4" providerId="LiveId" clId="{8839C90D-A0BC-41D0-9324-9C661B7E5A1D}" dt="2020-08-22T02:28:42.980" v="128" actId="478"/>
          <ac:spMkLst>
            <pc:docMk/>
            <pc:sldMk cId="1246805283" sldId="261"/>
            <ac:spMk id="3" creationId="{27FE4669-777F-4562-8C1B-89DEB1588661}"/>
          </ac:spMkLst>
        </pc:spChg>
      </pc:sldChg>
      <pc:sldChg chg="addSp delSp modSp add mod ord">
        <pc:chgData name="金子 慶三" userId="5f97e7106065bcb4" providerId="LiveId" clId="{8839C90D-A0BC-41D0-9324-9C661B7E5A1D}" dt="2020-08-25T06:20:02.757" v="486" actId="478"/>
        <pc:sldMkLst>
          <pc:docMk/>
          <pc:sldMk cId="1644047117" sldId="261"/>
        </pc:sldMkLst>
        <pc:spChg chg="mod">
          <ac:chgData name="金子 慶三" userId="5f97e7106065bcb4" providerId="LiveId" clId="{8839C90D-A0BC-41D0-9324-9C661B7E5A1D}" dt="2020-08-25T06:15:56.906" v="485" actId="1037"/>
          <ac:spMkLst>
            <pc:docMk/>
            <pc:sldMk cId="1644047117" sldId="261"/>
            <ac:spMk id="2" creationId="{5CFFB926-31B6-410E-8AA3-E21E67C0E618}"/>
          </ac:spMkLst>
        </pc:spChg>
        <pc:spChg chg="del">
          <ac:chgData name="金子 慶三" userId="5f97e7106065bcb4" providerId="LiveId" clId="{8839C90D-A0BC-41D0-9324-9C661B7E5A1D}" dt="2020-08-25T04:29:51.293" v="297" actId="478"/>
          <ac:spMkLst>
            <pc:docMk/>
            <pc:sldMk cId="1644047117" sldId="261"/>
            <ac:spMk id="3" creationId="{00000000-0000-0000-0000-000000000000}"/>
          </ac:spMkLst>
        </pc:spChg>
        <pc:spChg chg="del mod">
          <ac:chgData name="金子 慶三" userId="5f97e7106065bcb4" providerId="LiveId" clId="{8839C90D-A0BC-41D0-9324-9C661B7E5A1D}" dt="2020-08-25T06:20:02.757" v="486" actId="478"/>
          <ac:spMkLst>
            <pc:docMk/>
            <pc:sldMk cId="1644047117" sldId="261"/>
            <ac:spMk id="5" creationId="{24F344B8-3235-4BC5-BF95-5FCB126764F6}"/>
          </ac:spMkLst>
        </pc:spChg>
        <pc:spChg chg="add">
          <ac:chgData name="金子 慶三" userId="5f97e7106065bcb4" providerId="LiveId" clId="{8839C90D-A0BC-41D0-9324-9C661B7E5A1D}" dt="2020-08-25T04:29:51.774" v="298" actId="22"/>
          <ac:spMkLst>
            <pc:docMk/>
            <pc:sldMk cId="1644047117" sldId="261"/>
            <ac:spMk id="19" creationId="{88E9DBB5-EDC5-4731-8D70-A1F0CF8F0A34}"/>
          </ac:spMkLst>
        </pc:spChg>
        <pc:spChg chg="mod">
          <ac:chgData name="金子 慶三" userId="5f97e7106065bcb4" providerId="LiveId" clId="{8839C90D-A0BC-41D0-9324-9C661B7E5A1D}" dt="2020-08-25T04:45:45.929" v="432" actId="1037"/>
          <ac:spMkLst>
            <pc:docMk/>
            <pc:sldMk cId="1644047117" sldId="261"/>
            <ac:spMk id="35" creationId="{1E7E3055-5ADD-4BFE-B10D-171ECFD002D3}"/>
          </ac:spMkLst>
        </pc:spChg>
        <pc:spChg chg="mod">
          <ac:chgData name="金子 慶三" userId="5f97e7106065bcb4" providerId="LiveId" clId="{8839C90D-A0BC-41D0-9324-9C661B7E5A1D}" dt="2020-08-25T06:15:38.899" v="472" actId="1037"/>
          <ac:spMkLst>
            <pc:docMk/>
            <pc:sldMk cId="1644047117" sldId="261"/>
            <ac:spMk id="36" creationId="{9B87BA29-1F76-4FCF-A2B6-3B995915DA1E}"/>
          </ac:spMkLst>
        </pc:spChg>
        <pc:spChg chg="mod">
          <ac:chgData name="金子 慶三" userId="5f97e7106065bcb4" providerId="LiveId" clId="{8839C90D-A0BC-41D0-9324-9C661B7E5A1D}" dt="2020-08-25T06:15:45.475" v="475" actId="1037"/>
          <ac:spMkLst>
            <pc:docMk/>
            <pc:sldMk cId="1644047117" sldId="261"/>
            <ac:spMk id="37" creationId="{D9AD1A19-F6FF-43C9-A1F7-03ABB223447B}"/>
          </ac:spMkLst>
        </pc:spChg>
        <pc:spChg chg="mod">
          <ac:chgData name="金子 慶三" userId="5f97e7106065bcb4" providerId="LiveId" clId="{8839C90D-A0BC-41D0-9324-9C661B7E5A1D}" dt="2020-08-25T04:45:45.929" v="432" actId="1037"/>
          <ac:spMkLst>
            <pc:docMk/>
            <pc:sldMk cId="1644047117" sldId="261"/>
            <ac:spMk id="38" creationId="{949F5B70-9EF8-4AC3-BDDC-7C947B486BDC}"/>
          </ac:spMkLst>
        </pc:spChg>
        <pc:spChg chg="mod">
          <ac:chgData name="金子 慶三" userId="5f97e7106065bcb4" providerId="LiveId" clId="{8839C90D-A0BC-41D0-9324-9C661B7E5A1D}" dt="2020-08-25T06:15:49.995" v="482" actId="1037"/>
          <ac:spMkLst>
            <pc:docMk/>
            <pc:sldMk cId="1644047117" sldId="261"/>
            <ac:spMk id="39" creationId="{6938971D-62F2-4670-850C-3DD0BB23519F}"/>
          </ac:spMkLst>
        </pc:spChg>
        <pc:spChg chg="mod">
          <ac:chgData name="金子 慶三" userId="5f97e7106065bcb4" providerId="LiveId" clId="{8839C90D-A0BC-41D0-9324-9C661B7E5A1D}" dt="2020-08-25T04:45:45.929" v="432" actId="1037"/>
          <ac:spMkLst>
            <pc:docMk/>
            <pc:sldMk cId="1644047117" sldId="261"/>
            <ac:spMk id="40" creationId="{32A4BF40-EA71-41CC-B27A-67671830ECEE}"/>
          </ac:spMkLst>
        </pc:spChg>
        <pc:spChg chg="mod">
          <ac:chgData name="金子 慶三" userId="5f97e7106065bcb4" providerId="LiveId" clId="{8839C90D-A0BC-41D0-9324-9C661B7E5A1D}" dt="2020-08-25T04:45:45.929" v="432" actId="1037"/>
          <ac:spMkLst>
            <pc:docMk/>
            <pc:sldMk cId="1644047117" sldId="261"/>
            <ac:spMk id="43" creationId="{82E9BF78-9BA5-41F8-AC14-592CBF7A5B76}"/>
          </ac:spMkLst>
        </pc:spChg>
        <pc:spChg chg="del">
          <ac:chgData name="金子 慶三" userId="5f97e7106065bcb4" providerId="LiveId" clId="{8839C90D-A0BC-41D0-9324-9C661B7E5A1D}" dt="2020-08-25T04:45:01.290" v="413" actId="478"/>
          <ac:spMkLst>
            <pc:docMk/>
            <pc:sldMk cId="1644047117" sldId="261"/>
            <ac:spMk id="45" creationId="{00000000-0000-0000-0000-000000000000}"/>
          </ac:spMkLst>
        </pc:spChg>
        <pc:picChg chg="add mod ord">
          <ac:chgData name="金子 慶三" userId="5f97e7106065bcb4" providerId="LiveId" clId="{8839C90D-A0BC-41D0-9324-9C661B7E5A1D}" dt="2020-08-25T06:15:31.030" v="467" actId="1038"/>
          <ac:picMkLst>
            <pc:docMk/>
            <pc:sldMk cId="1644047117" sldId="261"/>
            <ac:picMk id="6" creationId="{1AB9D246-829A-4719-A762-E4BD7DAA15DB}"/>
          </ac:picMkLst>
        </pc:picChg>
        <pc:picChg chg="add del mod">
          <ac:chgData name="金子 慶三" userId="5f97e7106065bcb4" providerId="LiveId" clId="{8839C90D-A0BC-41D0-9324-9C661B7E5A1D}" dt="2020-08-25T04:07:21.823" v="280" actId="478"/>
          <ac:picMkLst>
            <pc:docMk/>
            <pc:sldMk cId="1644047117" sldId="261"/>
            <ac:picMk id="7" creationId="{8DB24C94-C12E-405E-BDE0-27EB13D94EC4}"/>
          </ac:picMkLst>
        </pc:picChg>
        <pc:picChg chg="add del mod">
          <ac:chgData name="金子 慶三" userId="5f97e7106065bcb4" providerId="LiveId" clId="{8839C90D-A0BC-41D0-9324-9C661B7E5A1D}" dt="2020-08-25T04:07:20.853" v="279" actId="478"/>
          <ac:picMkLst>
            <pc:docMk/>
            <pc:sldMk cId="1644047117" sldId="261"/>
            <ac:picMk id="9" creationId="{CDDFF515-F3ED-4F31-859A-AC3D8655172A}"/>
          </ac:picMkLst>
        </pc:picChg>
        <pc:picChg chg="add del mod">
          <ac:chgData name="金子 慶三" userId="5f97e7106065bcb4" providerId="LiveId" clId="{8839C90D-A0BC-41D0-9324-9C661B7E5A1D}" dt="2020-08-25T04:07:17.718" v="277" actId="478"/>
          <ac:picMkLst>
            <pc:docMk/>
            <pc:sldMk cId="1644047117" sldId="261"/>
            <ac:picMk id="11" creationId="{FCBD18C0-E1A1-454A-928A-7B50443B9165}"/>
          </ac:picMkLst>
        </pc:picChg>
        <pc:picChg chg="add del mod">
          <ac:chgData name="金子 慶三" userId="5f97e7106065bcb4" providerId="LiveId" clId="{8839C90D-A0BC-41D0-9324-9C661B7E5A1D}" dt="2020-08-25T03:36:35.746" v="270" actId="478"/>
          <ac:picMkLst>
            <pc:docMk/>
            <pc:sldMk cId="1644047117" sldId="261"/>
            <ac:picMk id="12" creationId="{CB40E4CD-2AE1-470D-A585-3650A918E502}"/>
          </ac:picMkLst>
        </pc:picChg>
        <pc:picChg chg="add del mod">
          <ac:chgData name="金子 慶三" userId="5f97e7106065bcb4" providerId="LiveId" clId="{8839C90D-A0BC-41D0-9324-9C661B7E5A1D}" dt="2020-08-25T04:07:19.617" v="278" actId="478"/>
          <ac:picMkLst>
            <pc:docMk/>
            <pc:sldMk cId="1644047117" sldId="261"/>
            <ac:picMk id="14" creationId="{DAAE98DC-0BA2-45CE-B098-36FFFE195F5C}"/>
          </ac:picMkLst>
        </pc:picChg>
        <pc:picChg chg="add del mod">
          <ac:chgData name="金子 慶三" userId="5f97e7106065bcb4" providerId="LiveId" clId="{8839C90D-A0BC-41D0-9324-9C661B7E5A1D}" dt="2020-08-25T04:10:58.845" v="282" actId="478"/>
          <ac:picMkLst>
            <pc:docMk/>
            <pc:sldMk cId="1644047117" sldId="261"/>
            <ac:picMk id="16" creationId="{F9085965-B3FC-4E1B-9C9D-22AB0B317400}"/>
          </ac:picMkLst>
        </pc:picChg>
        <pc:picChg chg="add del mod ord">
          <ac:chgData name="金子 慶三" userId="5f97e7106065bcb4" providerId="LiveId" clId="{8839C90D-A0BC-41D0-9324-9C661B7E5A1D}" dt="2020-08-25T06:15:13.501" v="459" actId="478"/>
          <ac:picMkLst>
            <pc:docMk/>
            <pc:sldMk cId="1644047117" sldId="261"/>
            <ac:picMk id="18" creationId="{BDD14F6F-C89F-4E97-8AC0-4381B155C504}"/>
          </ac:picMkLst>
        </pc:picChg>
        <pc:picChg chg="del">
          <ac:chgData name="金子 慶三" userId="5f97e7106065bcb4" providerId="LiveId" clId="{8839C90D-A0BC-41D0-9324-9C661B7E5A1D}" dt="2020-08-25T04:30:11.525" v="302" actId="478"/>
          <ac:picMkLst>
            <pc:docMk/>
            <pc:sldMk cId="1644047117" sldId="261"/>
            <ac:picMk id="32" creationId="{C5E754EA-F271-4C77-B686-E69C138ED6D5}"/>
          </ac:picMkLst>
        </pc:picChg>
      </pc:sldChg>
    </pc:docChg>
  </pc:docChgLst>
  <pc:docChgLst>
    <pc:chgData name="金子 慶三" userId="5f97e7106065bcb4" providerId="LiveId" clId="{4CDB691A-5B7D-46BD-B5CA-01008D914837}"/>
    <pc:docChg chg="custSel modSld">
      <pc:chgData name="金子 慶三" userId="5f97e7106065bcb4" providerId="LiveId" clId="{4CDB691A-5B7D-46BD-B5CA-01008D914837}" dt="2020-09-08T12:36:39.783" v="37" actId="1035"/>
      <pc:docMkLst>
        <pc:docMk/>
      </pc:docMkLst>
      <pc:sldChg chg="addSp delSp modSp mod">
        <pc:chgData name="金子 慶三" userId="5f97e7106065bcb4" providerId="LiveId" clId="{4CDB691A-5B7D-46BD-B5CA-01008D914837}" dt="2020-09-08T12:36:39.783" v="37" actId="1035"/>
        <pc:sldMkLst>
          <pc:docMk/>
          <pc:sldMk cId="1644047117" sldId="261"/>
        </pc:sldMkLst>
        <pc:spChg chg="mod">
          <ac:chgData name="金子 慶三" userId="5f97e7106065bcb4" providerId="LiveId" clId="{4CDB691A-5B7D-46BD-B5CA-01008D914837}" dt="2020-09-08T12:36:32.949" v="19" actId="1037"/>
          <ac:spMkLst>
            <pc:docMk/>
            <pc:sldMk cId="1644047117" sldId="261"/>
            <ac:spMk id="2" creationId="{5CFFB926-31B6-410E-8AA3-E21E67C0E618}"/>
          </ac:spMkLst>
        </pc:spChg>
        <pc:spChg chg="mod">
          <ac:chgData name="金子 慶三" userId="5f97e7106065bcb4" providerId="LiveId" clId="{4CDB691A-5B7D-46BD-B5CA-01008D914837}" dt="2020-09-08T12:36:39.783" v="37" actId="1035"/>
          <ac:spMkLst>
            <pc:docMk/>
            <pc:sldMk cId="1644047117" sldId="261"/>
            <ac:spMk id="4" creationId="{00000000-0000-0000-0000-000000000000}"/>
          </ac:spMkLst>
        </pc:spChg>
        <pc:spChg chg="mod">
          <ac:chgData name="金子 慶三" userId="5f97e7106065bcb4" providerId="LiveId" clId="{4CDB691A-5B7D-46BD-B5CA-01008D914837}" dt="2020-09-08T12:36:32.949" v="19" actId="1037"/>
          <ac:spMkLst>
            <pc:docMk/>
            <pc:sldMk cId="1644047117" sldId="261"/>
            <ac:spMk id="35" creationId="{1E7E3055-5ADD-4BFE-B10D-171ECFD002D3}"/>
          </ac:spMkLst>
        </pc:spChg>
        <pc:spChg chg="mod">
          <ac:chgData name="金子 慶三" userId="5f97e7106065bcb4" providerId="LiveId" clId="{4CDB691A-5B7D-46BD-B5CA-01008D914837}" dt="2020-09-08T12:36:32.949" v="19" actId="1037"/>
          <ac:spMkLst>
            <pc:docMk/>
            <pc:sldMk cId="1644047117" sldId="261"/>
            <ac:spMk id="36" creationId="{9B87BA29-1F76-4FCF-A2B6-3B995915DA1E}"/>
          </ac:spMkLst>
        </pc:spChg>
        <pc:spChg chg="mod">
          <ac:chgData name="金子 慶三" userId="5f97e7106065bcb4" providerId="LiveId" clId="{4CDB691A-5B7D-46BD-B5CA-01008D914837}" dt="2020-09-08T12:36:32.949" v="19" actId="1037"/>
          <ac:spMkLst>
            <pc:docMk/>
            <pc:sldMk cId="1644047117" sldId="261"/>
            <ac:spMk id="37" creationId="{D9AD1A19-F6FF-43C9-A1F7-03ABB223447B}"/>
          </ac:spMkLst>
        </pc:spChg>
        <pc:spChg chg="mod">
          <ac:chgData name="金子 慶三" userId="5f97e7106065bcb4" providerId="LiveId" clId="{4CDB691A-5B7D-46BD-B5CA-01008D914837}" dt="2020-09-08T12:36:32.949" v="19" actId="1037"/>
          <ac:spMkLst>
            <pc:docMk/>
            <pc:sldMk cId="1644047117" sldId="261"/>
            <ac:spMk id="38" creationId="{949F5B70-9EF8-4AC3-BDDC-7C947B486BDC}"/>
          </ac:spMkLst>
        </pc:spChg>
        <pc:spChg chg="mod">
          <ac:chgData name="金子 慶三" userId="5f97e7106065bcb4" providerId="LiveId" clId="{4CDB691A-5B7D-46BD-B5CA-01008D914837}" dt="2020-09-08T12:36:32.949" v="19" actId="1037"/>
          <ac:spMkLst>
            <pc:docMk/>
            <pc:sldMk cId="1644047117" sldId="261"/>
            <ac:spMk id="39" creationId="{6938971D-62F2-4670-850C-3DD0BB23519F}"/>
          </ac:spMkLst>
        </pc:spChg>
        <pc:spChg chg="mod">
          <ac:chgData name="金子 慶三" userId="5f97e7106065bcb4" providerId="LiveId" clId="{4CDB691A-5B7D-46BD-B5CA-01008D914837}" dt="2020-09-08T12:36:32.949" v="19" actId="1037"/>
          <ac:spMkLst>
            <pc:docMk/>
            <pc:sldMk cId="1644047117" sldId="261"/>
            <ac:spMk id="40" creationId="{32A4BF40-EA71-41CC-B27A-67671830ECEE}"/>
          </ac:spMkLst>
        </pc:spChg>
        <pc:spChg chg="mod">
          <ac:chgData name="金子 慶三" userId="5f97e7106065bcb4" providerId="LiveId" clId="{4CDB691A-5B7D-46BD-B5CA-01008D914837}" dt="2020-09-08T12:36:32.949" v="19" actId="1037"/>
          <ac:spMkLst>
            <pc:docMk/>
            <pc:sldMk cId="1644047117" sldId="261"/>
            <ac:spMk id="43" creationId="{82E9BF78-9BA5-41F8-AC14-592CBF7A5B76}"/>
          </ac:spMkLst>
        </pc:spChg>
        <pc:spChg chg="mod">
          <ac:chgData name="金子 慶三" userId="5f97e7106065bcb4" providerId="LiveId" clId="{4CDB691A-5B7D-46BD-B5CA-01008D914837}" dt="2020-09-08T12:36:39.783" v="37" actId="1035"/>
          <ac:spMkLst>
            <pc:docMk/>
            <pc:sldMk cId="1644047117" sldId="261"/>
            <ac:spMk id="44" creationId="{A02B0A61-4441-452C-A296-75215B7D24CB}"/>
          </ac:spMkLst>
        </pc:spChg>
        <pc:graphicFrameChg chg="add del mod">
          <ac:chgData name="金子 慶三" userId="5f97e7106065bcb4" providerId="LiveId" clId="{4CDB691A-5B7D-46BD-B5CA-01008D914837}" dt="2020-09-08T12:32:27.461" v="1" actId="478"/>
          <ac:graphicFrameMkLst>
            <pc:docMk/>
            <pc:sldMk cId="1644047117" sldId="261"/>
            <ac:graphicFrameMk id="3" creationId="{4F2AE593-356F-439E-890E-66AC61E1A933}"/>
          </ac:graphicFrameMkLst>
        </pc:graphicFrameChg>
        <pc:picChg chg="del">
          <ac:chgData name="金子 慶三" userId="5f97e7106065bcb4" providerId="LiveId" clId="{4CDB691A-5B7D-46BD-B5CA-01008D914837}" dt="2020-09-08T12:33:16.731" v="11" actId="478"/>
          <ac:picMkLst>
            <pc:docMk/>
            <pc:sldMk cId="1644047117" sldId="261"/>
            <ac:picMk id="6" creationId="{1AB9D246-829A-4719-A762-E4BD7DAA15DB}"/>
          </ac:picMkLst>
        </pc:picChg>
        <pc:picChg chg="add mod ord modCrop">
          <ac:chgData name="金子 慶三" userId="5f97e7106065bcb4" providerId="LiveId" clId="{4CDB691A-5B7D-46BD-B5CA-01008D914837}" dt="2020-09-08T12:36:32.949" v="19" actId="1037"/>
          <ac:picMkLst>
            <pc:docMk/>
            <pc:sldMk cId="1644047117" sldId="261"/>
            <ac:picMk id="7" creationId="{4BBF220F-91A6-478D-B8AC-83E009E7CE4F}"/>
          </ac:picMkLst>
        </pc:picChg>
      </pc:sldChg>
    </pc:docChg>
  </pc:docChgLst>
  <pc:docChgLst>
    <pc:chgData name="金子 慶三" userId="5f97e7106065bcb4" providerId="LiveId" clId="{1DB141EA-5864-4F92-AECD-87EC8617B0BC}"/>
    <pc:docChg chg="delSld">
      <pc:chgData name="金子 慶三" userId="5f97e7106065bcb4" providerId="LiveId" clId="{1DB141EA-5864-4F92-AECD-87EC8617B0BC}" dt="2020-08-25T14:03:07.961" v="0" actId="47"/>
      <pc:docMkLst>
        <pc:docMk/>
      </pc:docMkLst>
      <pc:sldChg chg="del">
        <pc:chgData name="金子 慶三" userId="5f97e7106065bcb4" providerId="LiveId" clId="{1DB141EA-5864-4F92-AECD-87EC8617B0BC}" dt="2020-08-25T14:03:07.961" v="0" actId="47"/>
        <pc:sldMkLst>
          <pc:docMk/>
          <pc:sldMk cId="3017841347" sldId="256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A4326C-76CD-4D83-8DAF-7D0B0F348BA8}" type="datetimeFigureOut">
              <a:rPr kumimoji="1" lang="ja-JP" altLang="en-US" smtClean="0"/>
              <a:t>2020/9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EA7912-DA0F-4064-87F5-4C2B5192BD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025396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A4326C-76CD-4D83-8DAF-7D0B0F348BA8}" type="datetimeFigureOut">
              <a:rPr kumimoji="1" lang="ja-JP" altLang="en-US" smtClean="0"/>
              <a:t>2020/9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EA7912-DA0F-4064-87F5-4C2B5192BD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248372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A4326C-76CD-4D83-8DAF-7D0B0F348BA8}" type="datetimeFigureOut">
              <a:rPr kumimoji="1" lang="ja-JP" altLang="en-US" smtClean="0"/>
              <a:t>2020/9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EA7912-DA0F-4064-87F5-4C2B5192BD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170408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A4326C-76CD-4D83-8DAF-7D0B0F348BA8}" type="datetimeFigureOut">
              <a:rPr kumimoji="1" lang="ja-JP" altLang="en-US" smtClean="0"/>
              <a:t>2020/9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EA7912-DA0F-4064-87F5-4C2B5192BD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410839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A4326C-76CD-4D83-8DAF-7D0B0F348BA8}" type="datetimeFigureOut">
              <a:rPr kumimoji="1" lang="ja-JP" altLang="en-US" smtClean="0"/>
              <a:t>2020/9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EA7912-DA0F-4064-87F5-4C2B5192BD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360566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A4326C-76CD-4D83-8DAF-7D0B0F348BA8}" type="datetimeFigureOut">
              <a:rPr kumimoji="1" lang="ja-JP" altLang="en-US" smtClean="0"/>
              <a:t>2020/9/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EA7912-DA0F-4064-87F5-4C2B5192BD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340314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A4326C-76CD-4D83-8DAF-7D0B0F348BA8}" type="datetimeFigureOut">
              <a:rPr kumimoji="1" lang="ja-JP" altLang="en-US" smtClean="0"/>
              <a:t>2020/9/8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EA7912-DA0F-4064-87F5-4C2B5192BD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763817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A4326C-76CD-4D83-8DAF-7D0B0F348BA8}" type="datetimeFigureOut">
              <a:rPr kumimoji="1" lang="ja-JP" altLang="en-US" smtClean="0"/>
              <a:t>2020/9/8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EA7912-DA0F-4064-87F5-4C2B5192BD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347894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A4326C-76CD-4D83-8DAF-7D0B0F348BA8}" type="datetimeFigureOut">
              <a:rPr kumimoji="1" lang="ja-JP" altLang="en-US" smtClean="0"/>
              <a:t>2020/9/8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EA7912-DA0F-4064-87F5-4C2B5192BD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88767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A4326C-76CD-4D83-8DAF-7D0B0F348BA8}" type="datetimeFigureOut">
              <a:rPr kumimoji="1" lang="ja-JP" altLang="en-US" smtClean="0"/>
              <a:t>2020/9/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EA7912-DA0F-4064-87F5-4C2B5192BD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677809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A4326C-76CD-4D83-8DAF-7D0B0F348BA8}" type="datetimeFigureOut">
              <a:rPr kumimoji="1" lang="ja-JP" altLang="en-US" smtClean="0"/>
              <a:t>2020/9/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EA7912-DA0F-4064-87F5-4C2B5192BD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569147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A4326C-76CD-4D83-8DAF-7D0B0F348BA8}" type="datetimeFigureOut">
              <a:rPr kumimoji="1" lang="ja-JP" altLang="en-US" smtClean="0"/>
              <a:t>2020/9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EA7912-DA0F-4064-87F5-4C2B5192BD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54187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図 6">
            <a:extLst>
              <a:ext uri="{FF2B5EF4-FFF2-40B4-BE49-F238E27FC236}">
                <a16:creationId xmlns:a16="http://schemas.microsoft.com/office/drawing/2014/main" id="{4BBF220F-91A6-478D-B8AC-83E009E7CE4F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96"/>
          <a:stretch/>
        </p:blipFill>
        <p:spPr>
          <a:xfrm>
            <a:off x="682033" y="2006598"/>
            <a:ext cx="5365880" cy="3437150"/>
          </a:xfrm>
          <a:prstGeom prst="rect">
            <a:avLst/>
          </a:prstGeom>
        </p:spPr>
      </p:pic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1E7E3055-5ADD-4BFE-B10D-171ECFD002D3}"/>
              </a:ext>
            </a:extLst>
          </p:cNvPr>
          <p:cNvSpPr txBox="1"/>
          <p:nvPr/>
        </p:nvSpPr>
        <p:spPr>
          <a:xfrm>
            <a:off x="3033790" y="5515727"/>
            <a:ext cx="55976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b="1" dirty="0">
                <a:latin typeface="Arial" panose="020B0604020202020204" pitchFamily="34" charset="0"/>
                <a:cs typeface="Arial" panose="020B0604020202020204" pitchFamily="34" charset="0"/>
              </a:rPr>
              <a:t>Patient’s</a:t>
            </a:r>
          </a:p>
          <a:p>
            <a:r>
              <a:rPr lang="en-US" altLang="ja-JP" sz="700" b="1" dirty="0">
                <a:latin typeface="Arial" panose="020B0604020202020204" pitchFamily="34" charset="0"/>
                <a:cs typeface="Arial" panose="020B0604020202020204" pitchFamily="34" charset="0"/>
              </a:rPr>
              <a:t>serum</a:t>
            </a:r>
            <a:endParaRPr kumimoji="1" lang="ja-JP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9B87BA29-1F76-4FCF-A2B6-3B995915DA1E}"/>
              </a:ext>
            </a:extLst>
          </p:cNvPr>
          <p:cNvSpPr txBox="1"/>
          <p:nvPr/>
        </p:nvSpPr>
        <p:spPr>
          <a:xfrm>
            <a:off x="3715718" y="5515727"/>
            <a:ext cx="129614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700" b="1" dirty="0">
                <a:latin typeface="Arial" panose="020B0604020202020204" pitchFamily="34" charset="0"/>
                <a:cs typeface="Arial" panose="020B0604020202020204" pitchFamily="34" charset="0"/>
              </a:rPr>
              <a:t>Preexisting</a:t>
            </a:r>
          </a:p>
          <a:p>
            <a:r>
              <a:rPr lang="en-US" altLang="ja-JP" sz="700" b="1" dirty="0">
                <a:latin typeface="Arial" panose="020B0604020202020204" pitchFamily="34" charset="0"/>
                <a:cs typeface="Arial" panose="020B0604020202020204" pitchFamily="34" charset="0"/>
              </a:rPr>
              <a:t>SFT</a:t>
            </a: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D9AD1A19-F6FF-43C9-A1F7-03ABB223447B}"/>
              </a:ext>
            </a:extLst>
          </p:cNvPr>
          <p:cNvSpPr txBox="1"/>
          <p:nvPr/>
        </p:nvSpPr>
        <p:spPr>
          <a:xfrm>
            <a:off x="4555613" y="5515727"/>
            <a:ext cx="115212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700" b="1" dirty="0">
                <a:latin typeface="Arial" panose="020B0604020202020204" pitchFamily="34" charset="0"/>
                <a:cs typeface="Arial" panose="020B0604020202020204" pitchFamily="34" charset="0"/>
              </a:rPr>
              <a:t>Peri-renal</a:t>
            </a:r>
          </a:p>
          <a:p>
            <a:r>
              <a:rPr lang="en-US" altLang="ja-JP" sz="700" b="1" dirty="0">
                <a:latin typeface="Arial" panose="020B0604020202020204" pitchFamily="34" charset="0"/>
                <a:cs typeface="Arial" panose="020B0604020202020204" pitchFamily="34" charset="0"/>
              </a:rPr>
              <a:t>tumor</a:t>
            </a: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949F5B70-9EF8-4AC3-BDDC-7C947B486BDC}"/>
              </a:ext>
            </a:extLst>
          </p:cNvPr>
          <p:cNvSpPr txBox="1"/>
          <p:nvPr/>
        </p:nvSpPr>
        <p:spPr>
          <a:xfrm>
            <a:off x="2298278" y="5515727"/>
            <a:ext cx="4940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b="1" dirty="0">
                <a:latin typeface="Arial" panose="020B0604020202020204" pitchFamily="34" charset="0"/>
                <a:cs typeface="Arial" panose="020B0604020202020204" pitchFamily="34" charset="0"/>
              </a:rPr>
              <a:t>Normal</a:t>
            </a:r>
          </a:p>
          <a:p>
            <a:r>
              <a:rPr kumimoji="1" lang="en-US" altLang="ja-JP" sz="700" b="1" dirty="0">
                <a:latin typeface="Arial" panose="020B0604020202020204" pitchFamily="34" charset="0"/>
                <a:cs typeface="Arial" panose="020B0604020202020204" pitchFamily="34" charset="0"/>
              </a:rPr>
              <a:t>serum</a:t>
            </a:r>
            <a:endParaRPr kumimoji="1" lang="ja-JP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6938971D-62F2-4670-850C-3DD0BB23519F}"/>
              </a:ext>
            </a:extLst>
          </p:cNvPr>
          <p:cNvSpPr txBox="1"/>
          <p:nvPr/>
        </p:nvSpPr>
        <p:spPr>
          <a:xfrm>
            <a:off x="5281613" y="5524194"/>
            <a:ext cx="115212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700" b="1" dirty="0">
                <a:latin typeface="Arial" panose="020B0604020202020204" pitchFamily="34" charset="0"/>
                <a:cs typeface="Arial" panose="020B0604020202020204" pitchFamily="34" charset="0"/>
              </a:rPr>
              <a:t>Peri-renal</a:t>
            </a:r>
          </a:p>
          <a:p>
            <a:r>
              <a:rPr lang="en-US" altLang="ja-JP" sz="700" b="1" dirty="0">
                <a:latin typeface="Arial" panose="020B0604020202020204" pitchFamily="34" charset="0"/>
                <a:cs typeface="Arial" panose="020B0604020202020204" pitchFamily="34" charset="0"/>
              </a:rPr>
              <a:t>tumor</a:t>
            </a: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32A4BF40-EA71-41CC-B27A-67671830ECEE}"/>
              </a:ext>
            </a:extLst>
          </p:cNvPr>
          <p:cNvSpPr txBox="1"/>
          <p:nvPr/>
        </p:nvSpPr>
        <p:spPr>
          <a:xfrm>
            <a:off x="1385909" y="5515727"/>
            <a:ext cx="75212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b="1" dirty="0">
                <a:latin typeface="Arial" panose="020B0604020202020204" pitchFamily="34" charset="0"/>
                <a:cs typeface="Arial" panose="020B0604020202020204" pitchFamily="34" charset="0"/>
              </a:rPr>
              <a:t>Recombinant</a:t>
            </a:r>
          </a:p>
          <a:p>
            <a:r>
              <a:rPr lang="en-US" altLang="ja-JP" sz="700" b="1" dirty="0">
                <a:latin typeface="Arial" panose="020B0604020202020204" pitchFamily="34" charset="0"/>
                <a:cs typeface="Arial" panose="020B0604020202020204" pitchFamily="34" charset="0"/>
              </a:rPr>
              <a:t>IGF-2</a:t>
            </a:r>
            <a:endParaRPr kumimoji="1" lang="ja-JP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82E9BF78-9BA5-41F8-AC14-592CBF7A5B76}"/>
              </a:ext>
            </a:extLst>
          </p:cNvPr>
          <p:cNvSpPr txBox="1"/>
          <p:nvPr/>
        </p:nvSpPr>
        <p:spPr>
          <a:xfrm>
            <a:off x="697751" y="5515727"/>
            <a:ext cx="61266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b="1" dirty="0">
                <a:latin typeface="Arial" panose="020B0604020202020204" pitchFamily="34" charset="0"/>
                <a:cs typeface="Arial" panose="020B0604020202020204" pitchFamily="34" charset="0"/>
              </a:rPr>
              <a:t>Protein</a:t>
            </a:r>
          </a:p>
          <a:p>
            <a:r>
              <a:rPr lang="en-US" altLang="ja-JP" sz="700" b="1" dirty="0">
                <a:latin typeface="Arial" panose="020B0604020202020204" pitchFamily="34" charset="0"/>
                <a:cs typeface="Arial" panose="020B0604020202020204" pitchFamily="34" charset="0"/>
              </a:rPr>
              <a:t>standards</a:t>
            </a:r>
            <a:endParaRPr kumimoji="1" lang="ja-JP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A02B0A61-4441-452C-A296-75215B7D24CB}"/>
              </a:ext>
            </a:extLst>
          </p:cNvPr>
          <p:cNvSpPr txBox="1"/>
          <p:nvPr/>
        </p:nvSpPr>
        <p:spPr>
          <a:xfrm>
            <a:off x="513947" y="6720790"/>
            <a:ext cx="780095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Uncropped</a:t>
            </a:r>
            <a:r>
              <a:rPr kumimoji="1" lang="ja-JP" alt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western</a:t>
            </a:r>
            <a:r>
              <a:rPr kumimoji="1" lang="ja-JP" alt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immunoblot</a:t>
            </a:r>
            <a:r>
              <a:rPr kumimoji="1" lang="ja-JP" alt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image</a:t>
            </a:r>
            <a:r>
              <a:rPr kumimoji="1" lang="ja-JP" alt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related</a:t>
            </a:r>
            <a:r>
              <a:rPr kumimoji="1" lang="ja-JP" alt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to</a:t>
            </a:r>
            <a:r>
              <a:rPr kumimoji="1" lang="ja-JP" alt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Fig.1c</a:t>
            </a:r>
            <a:r>
              <a:rPr kumimoji="1" lang="ja-JP" alt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4" name="テキスト ボックス 3"/>
          <p:cNvSpPr txBox="1"/>
          <p:nvPr/>
        </p:nvSpPr>
        <p:spPr>
          <a:xfrm>
            <a:off x="513947" y="7084992"/>
            <a:ext cx="6274356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Western immunoblot analysis with anti-IGF-2 antibody of recombinant IGF-2 (2nd lane),</a:t>
            </a:r>
            <a:r>
              <a:rPr lang="ja-JP" alt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the samples shown in Fig.1c (from 3</a:t>
            </a:r>
            <a:r>
              <a:rPr lang="en-US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rd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to 6</a:t>
            </a:r>
            <a:r>
              <a:rPr lang="en-US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th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lane) and another portion of the autopsy peri-renal tumor sample (30µg of total protein)</a:t>
            </a:r>
            <a:r>
              <a:rPr lang="ja-JP" alt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(7th lane). </a:t>
            </a:r>
            <a:r>
              <a:rPr lang="en-US" sz="1600">
                <a:latin typeface="Arial" panose="020B0604020202020204" pitchFamily="34" charset="0"/>
                <a:cs typeface="Arial" panose="020B0604020202020204" pitchFamily="34" charset="0"/>
              </a:rPr>
              <a:t>The rectangular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area indicates the immunoblot image shown in Fig.1c. </a:t>
            </a:r>
          </a:p>
        </p:txBody>
      </p:sp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5CFFB926-31B6-410E-8AA3-E21E67C0E618}"/>
              </a:ext>
            </a:extLst>
          </p:cNvPr>
          <p:cNvSpPr/>
          <p:nvPr/>
        </p:nvSpPr>
        <p:spPr>
          <a:xfrm>
            <a:off x="2215132" y="3948872"/>
            <a:ext cx="2914430" cy="1260088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88E9DBB5-EDC5-4731-8D70-A1F0CF8F0A34}"/>
              </a:ext>
            </a:extLst>
          </p:cNvPr>
          <p:cNvSpPr txBox="1"/>
          <p:nvPr/>
        </p:nvSpPr>
        <p:spPr>
          <a:xfrm>
            <a:off x="163471" y="204623"/>
            <a:ext cx="19030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Additional</a:t>
            </a:r>
            <a:r>
              <a:rPr lang="ja-JP" altLang="en-US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file</a:t>
            </a:r>
            <a:r>
              <a:rPr lang="ja-JP" altLang="en-US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440471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86</TotalTime>
  <Words>85</Words>
  <Application>Microsoft Office PowerPoint</Application>
  <PresentationFormat>画面に合わせる (4:3)</PresentationFormat>
  <Paragraphs>17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keizo</dc:creator>
  <cp:lastModifiedBy>金子 慶三</cp:lastModifiedBy>
  <cp:revision>18</cp:revision>
  <cp:lastPrinted>2020-08-22T02:16:26Z</cp:lastPrinted>
  <dcterms:created xsi:type="dcterms:W3CDTF">2015-05-16T10:03:43Z</dcterms:created>
  <dcterms:modified xsi:type="dcterms:W3CDTF">2020-09-08T12:36:47Z</dcterms:modified>
</cp:coreProperties>
</file>